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64" r:id="rId3"/>
    <p:sldId id="257" r:id="rId4"/>
    <p:sldId id="258" r:id="rId5"/>
    <p:sldId id="259" r:id="rId6"/>
    <p:sldId id="260" r:id="rId7"/>
    <p:sldId id="261" r:id="rId8"/>
    <p:sldId id="263" r:id="rId9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5052"/>
    <p:restoredTop sz="96296"/>
  </p:normalViewPr>
  <p:slideViewPr>
    <p:cSldViewPr snapToGrid="0" snapToObjects="1">
      <p:cViewPr varScale="1">
        <p:scale>
          <a:sx n="105" d="100"/>
          <a:sy n="105" d="100"/>
        </p:scale>
        <p:origin x="200" y="4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2B7D040-99C5-C94B-AEC1-9C19DEDFE2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12D8F377-ABD6-D946-939C-AA1BDBFCEB5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20211A3-F941-544E-9B59-F01F7F9CD2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03CD2-848E-A342-AE06-455DE5381AD6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3D47502-7DF3-7A47-97DB-81F5A2A4F0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5F48939-63F6-FD46-B09D-907ED7311D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AC1DC-B0C7-D84C-ADB2-23F4F463E1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47518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3F92616-1B3E-5342-9099-6DD1D2BF6F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1FD4AE5-9703-1347-AC6D-1043B138A6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2808E1E-8466-D54C-9307-43DBB4037A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03CD2-848E-A342-AE06-455DE5381AD6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3C96F6B-E3FD-3B43-80E6-D5B80DCF82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382468A-3843-5142-8A1B-9727A7E8EC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AC1DC-B0C7-D84C-ADB2-23F4F463E1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49462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B968C5C3-14E8-7B49-8DF4-DA5DB1D084C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32334E0-30C8-5245-8D78-E0AADB2243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A95AD33-5ED3-544F-93FC-78C8C354C4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03CD2-848E-A342-AE06-455DE5381AD6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FE9C929-0A25-8B4A-B48C-82A53A5BFE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D7B10C9-B1BE-7940-AF5C-7C0F45ECEB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AC1DC-B0C7-D84C-ADB2-23F4F463E1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46946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D3F5755-B629-2F4F-9C4E-7CDFC76A59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3241AFB-517F-F14C-90B8-D2EBCEE6A7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49E5839-76E0-904C-9A23-685FF135B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03CD2-848E-A342-AE06-455DE5381AD6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A68E56F-D9E9-2640-8A7C-9FDCDD9AA7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C42C7B3-E8AD-474C-88A4-128E4893EE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AC1DC-B0C7-D84C-ADB2-23F4F463E1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2274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7C30A05-B63E-A946-886E-CE84F46D52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04869B9-E296-2340-B2B5-D9ECC0BEEA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9CBB267-D1BA-174B-89F6-C6BEA7F0A6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03CD2-848E-A342-AE06-455DE5381AD6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0160D81-D914-2141-A83E-2ABD9EA0A2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E94C31B-5449-5049-A12A-92AEF7CB32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AC1DC-B0C7-D84C-ADB2-23F4F463E1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41213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00F5A26-D7C0-4747-9E4B-59CBF6E55F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3EFF657-BDEC-8940-B3EE-DC605E4B2F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4778F525-E5DB-A14B-857A-DC679807F9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DA65406-B8A3-364A-B7CD-755954010C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03CD2-848E-A342-AE06-455DE5381AD6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A1D93B1-FC63-AB4A-9727-E7A30475E4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6866C3B-F693-8944-ACE0-749443B163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AC1DC-B0C7-D84C-ADB2-23F4F463E1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251836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6BEDB99-17F2-2648-A9EF-1756717A96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E8C6467-D3A4-F840-A84B-0A20F6ECE0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D1370B57-975C-3F40-B115-12A042CC75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36B633D1-9454-7B4D-A0CC-DACB8A6F9B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F50E7758-77E6-7E49-9FDA-2204A41170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24BF79F7-0209-3848-AFB9-D735E55164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03CD2-848E-A342-AE06-455DE5381AD6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0B9AF83A-6E69-9B48-B863-949F703E78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5140C631-1FFF-5A47-BD89-09C4190D2F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AC1DC-B0C7-D84C-ADB2-23F4F463E1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68963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30F8B3B-57BB-544F-9E3E-2713FE23C5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69FE327-FB8B-D84A-ABE2-2010F9C8A8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03CD2-848E-A342-AE06-455DE5381AD6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0C345623-6241-0E4B-BC39-CE171DC427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6F579F95-4EDD-7A4F-A0B2-F200CA579B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AC1DC-B0C7-D84C-ADB2-23F4F463E1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972997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EE57ED4A-E073-414F-A659-4C71302ADE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03CD2-848E-A342-AE06-455DE5381AD6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48F80A01-79B6-CC4E-B932-4EA5E023AE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73451B86-8D2B-6946-B857-FD24252848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AC1DC-B0C7-D84C-ADB2-23F4F463E1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287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3BA2161-133F-7943-A2C1-FFC6D186FD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1078E0B-275A-4044-A389-913FD9AD4D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2DEF68AF-26F0-6E4E-9520-1861709711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C855CBD-648E-1444-9E7C-FF9289CD73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03CD2-848E-A342-AE06-455DE5381AD6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365D957-8DA3-2149-911F-2AF9952DFD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488C087-F079-BE48-B3A8-034CD808ED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AC1DC-B0C7-D84C-ADB2-23F4F463E1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44969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C4F2E9C-EF8B-CE42-BCEF-CD6BA3758C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136E949-3ED7-8648-9253-83AF79010D4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20E632E-8B9B-7041-8B13-745472059B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200B6C1-7F2E-7845-8355-B93A5339EC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03CD2-848E-A342-AE06-455DE5381AD6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F105B02-59DA-3B46-87C3-A651D1EB9F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6F33C81-AC69-3D4E-9320-D9B299DF10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AC1DC-B0C7-D84C-ADB2-23F4F463E1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7678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7CAE7C8-8C07-FB49-80CF-68846E2321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74EC99F-C6DB-134B-B9ED-709E5590EB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36F3E4E-BAE3-D34B-93EF-5477E86D908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B03CD2-848E-A342-AE06-455DE5381AD6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147C162-B032-474C-9528-8003EEE94B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B60AB04-C997-A748-A5E1-BBD8AAC4F6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CAC1DC-B0C7-D84C-ADB2-23F4F463E18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21311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0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22.png"/><Relationship Id="rId4" Type="http://schemas.openxmlformats.org/officeDocument/2006/relationships/image" Target="../media/image19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e 11">
            <a:extLst>
              <a:ext uri="{FF2B5EF4-FFF2-40B4-BE49-F238E27FC236}">
                <a16:creationId xmlns:a16="http://schemas.microsoft.com/office/drawing/2014/main" id="{733F1797-D033-CD86-DC89-E827A5EEF8FC}"/>
              </a:ext>
            </a:extLst>
          </p:cNvPr>
          <p:cNvGrpSpPr/>
          <p:nvPr/>
        </p:nvGrpSpPr>
        <p:grpSpPr>
          <a:xfrm>
            <a:off x="3533754" y="850797"/>
            <a:ext cx="5756910" cy="4632823"/>
            <a:chOff x="3533754" y="850797"/>
            <a:chExt cx="5756910" cy="4632823"/>
          </a:xfrm>
        </p:grpSpPr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FE412275-B196-3F4C-B900-0A05236EC004}"/>
                </a:ext>
              </a:extLst>
            </p:cNvPr>
            <p:cNvSpPr txBox="1"/>
            <p:nvPr/>
          </p:nvSpPr>
          <p:spPr>
            <a:xfrm>
              <a:off x="3533754" y="4314069"/>
              <a:ext cx="5756910" cy="1169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1 : Surgical procedure</a:t>
              </a:r>
            </a:p>
            <a:p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 : First time of </a:t>
              </a:r>
              <a:r>
                <a:rPr lang="fr-F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duced</a:t>
              </a:r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embrane technique </a:t>
              </a:r>
              <a:r>
                <a:rPr lang="fr-F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</a:t>
              </a:r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 </a:t>
              </a:r>
              <a:r>
                <a:rPr lang="fr-F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iezotomy</a:t>
              </a:r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4mm </a:t>
              </a:r>
              <a:r>
                <a:rPr lang="fr-F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ritical</a:t>
              </a:r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one</a:t>
              </a:r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efect</a:t>
              </a:r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white </a:t>
              </a:r>
              <a:r>
                <a:rPr lang="fr-F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rrow</a:t>
              </a:r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and </a:t>
              </a:r>
              <a:r>
                <a:rPr lang="fr-F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steosynthesis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 : First time of </a:t>
              </a:r>
              <a:r>
                <a:rPr lang="fr-F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duced</a:t>
              </a:r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embrane technique </a:t>
              </a:r>
              <a:r>
                <a:rPr lang="fr-F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</a:t>
              </a:r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 PMMA </a:t>
              </a:r>
              <a:r>
                <a:rPr lang="fr-F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pacer</a:t>
              </a:r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white </a:t>
              </a:r>
              <a:r>
                <a:rPr lang="fr-F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rrow</a:t>
              </a:r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in place</a:t>
              </a:r>
            </a:p>
            <a:p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 : Second time of </a:t>
              </a:r>
              <a:r>
                <a:rPr lang="fr-F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duced</a:t>
              </a:r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embrane technique </a:t>
              </a:r>
              <a:r>
                <a:rPr lang="fr-F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</a:t>
              </a:r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 clamp holding the </a:t>
              </a:r>
              <a:r>
                <a:rPr lang="fr-F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duced</a:t>
              </a:r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embrane (white </a:t>
              </a:r>
              <a:r>
                <a:rPr lang="fr-F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rrow</a:t>
              </a:r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and the PMMA </a:t>
              </a:r>
              <a:r>
                <a:rPr lang="fr-F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pacer</a:t>
              </a:r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n place</a:t>
              </a:r>
            </a:p>
            <a:p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 : </a:t>
              </a:r>
              <a:r>
                <a:rPr lang="fr-F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yngenic</a:t>
              </a:r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one</a:t>
              </a:r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raft</a:t>
              </a:r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white </a:t>
              </a:r>
              <a:r>
                <a:rPr lang="fr-F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rrow</a:t>
              </a:r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  <p:grpSp>
          <p:nvGrpSpPr>
            <p:cNvPr id="21" name="Groupe 20">
              <a:extLst>
                <a:ext uri="{FF2B5EF4-FFF2-40B4-BE49-F238E27FC236}">
                  <a16:creationId xmlns:a16="http://schemas.microsoft.com/office/drawing/2014/main" id="{442EF927-D091-8007-C9A7-96BAD6EC370D}"/>
                </a:ext>
              </a:extLst>
            </p:cNvPr>
            <p:cNvGrpSpPr/>
            <p:nvPr/>
          </p:nvGrpSpPr>
          <p:grpSpPr>
            <a:xfrm>
              <a:off x="3533754" y="851022"/>
              <a:ext cx="5386417" cy="3464317"/>
              <a:chOff x="3533754" y="851022"/>
              <a:chExt cx="5386417" cy="3464317"/>
            </a:xfrm>
          </p:grpSpPr>
          <p:pic>
            <p:nvPicPr>
              <p:cNvPr id="7" name="Image 6">
                <a:extLst>
                  <a:ext uri="{FF2B5EF4-FFF2-40B4-BE49-F238E27FC236}">
                    <a16:creationId xmlns:a16="http://schemas.microsoft.com/office/drawing/2014/main" id="{78CE4C56-D328-314B-A641-DB0095421D8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33754" y="851022"/>
                <a:ext cx="2653665" cy="1692910"/>
              </a:xfrm>
              <a:prstGeom prst="rect">
                <a:avLst/>
              </a:prstGeom>
              <a:ln>
                <a:solidFill>
                  <a:srgbClr val="000000"/>
                </a:solidFill>
              </a:ln>
            </p:spPr>
          </p:pic>
          <p:pic>
            <p:nvPicPr>
              <p:cNvPr id="8" name="Image 7">
                <a:extLst>
                  <a:ext uri="{FF2B5EF4-FFF2-40B4-BE49-F238E27FC236}">
                    <a16:creationId xmlns:a16="http://schemas.microsoft.com/office/drawing/2014/main" id="{6FAB6872-DC69-6249-91B0-D0AF5B484AFF}"/>
                  </a:ext>
                </a:extLst>
              </p:cNvPr>
              <p:cNvPicPr>
                <a:picLocks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266971" y="851022"/>
                <a:ext cx="2653200" cy="1691005"/>
              </a:xfrm>
              <a:prstGeom prst="rect">
                <a:avLst/>
              </a:prstGeom>
              <a:ln>
                <a:solidFill>
                  <a:srgbClr val="000000"/>
                </a:solidFill>
              </a:ln>
            </p:spPr>
          </p:pic>
          <p:pic>
            <p:nvPicPr>
              <p:cNvPr id="9" name="Image 8">
                <a:extLst>
                  <a:ext uri="{FF2B5EF4-FFF2-40B4-BE49-F238E27FC236}">
                    <a16:creationId xmlns:a16="http://schemas.microsoft.com/office/drawing/2014/main" id="{FC297EB8-D145-2E42-A7A9-16B60CBE10F4}"/>
                  </a:ext>
                </a:extLst>
              </p:cNvPr>
              <p:cNvPicPr>
                <a:picLocks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33754" y="2623699"/>
                <a:ext cx="2653665" cy="1690370"/>
              </a:xfrm>
              <a:prstGeom prst="rect">
                <a:avLst/>
              </a:prstGeom>
              <a:ln>
                <a:solidFill>
                  <a:srgbClr val="000000"/>
                </a:solidFill>
              </a:ln>
            </p:spPr>
          </p:pic>
          <p:pic>
            <p:nvPicPr>
              <p:cNvPr id="10" name="Image 9">
                <a:extLst>
                  <a:ext uri="{FF2B5EF4-FFF2-40B4-BE49-F238E27FC236}">
                    <a16:creationId xmlns:a16="http://schemas.microsoft.com/office/drawing/2014/main" id="{B0E0A5FE-4606-A342-B00C-14BC866904B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266971" y="2623699"/>
                <a:ext cx="2008505" cy="1691640"/>
              </a:xfrm>
              <a:prstGeom prst="rect">
                <a:avLst/>
              </a:prstGeom>
              <a:ln>
                <a:solidFill>
                  <a:srgbClr val="000000"/>
                </a:solidFill>
              </a:ln>
            </p:spPr>
          </p:pic>
          <p:cxnSp>
            <p:nvCxnSpPr>
              <p:cNvPr id="3" name="Connecteur droit avec flèche 2">
                <a:extLst>
                  <a:ext uri="{FF2B5EF4-FFF2-40B4-BE49-F238E27FC236}">
                    <a16:creationId xmlns:a16="http://schemas.microsoft.com/office/drawing/2014/main" id="{660C38D4-0E53-EADA-6DD4-24B67C666A7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996975" y="1715638"/>
                <a:ext cx="675163" cy="0"/>
              </a:xfrm>
              <a:prstGeom prst="straightConnector1">
                <a:avLst/>
              </a:prstGeom>
              <a:ln w="2540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Connecteur droit avec flèche 15">
                <a:extLst>
                  <a:ext uri="{FF2B5EF4-FFF2-40B4-BE49-F238E27FC236}">
                    <a16:creationId xmlns:a16="http://schemas.microsoft.com/office/drawing/2014/main" id="{A4E04F2E-01D2-91F3-BA13-D0255DCC90D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700836" y="1667948"/>
                <a:ext cx="635558" cy="0"/>
              </a:xfrm>
              <a:prstGeom prst="straightConnector1">
                <a:avLst/>
              </a:prstGeom>
              <a:ln w="2540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Connecteur droit avec flèche 17">
                <a:extLst>
                  <a:ext uri="{FF2B5EF4-FFF2-40B4-BE49-F238E27FC236}">
                    <a16:creationId xmlns:a16="http://schemas.microsoft.com/office/drawing/2014/main" id="{F43EBF26-0B90-6FC3-A6D4-867839726FA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87450" y="3640601"/>
                <a:ext cx="635558" cy="0"/>
              </a:xfrm>
              <a:prstGeom prst="straightConnector1">
                <a:avLst/>
              </a:prstGeom>
              <a:ln w="2540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Connecteur droit avec flèche 18">
                <a:extLst>
                  <a:ext uri="{FF2B5EF4-FFF2-40B4-BE49-F238E27FC236}">
                    <a16:creationId xmlns:a16="http://schemas.microsoft.com/office/drawing/2014/main" id="{96C00D06-4F72-94D2-F148-835F14D5AFF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383057" y="3661867"/>
                <a:ext cx="635558" cy="0"/>
              </a:xfrm>
              <a:prstGeom prst="straightConnector1">
                <a:avLst/>
              </a:prstGeom>
              <a:ln w="2540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id="{8825C3DB-89D9-104D-7480-FA6C67B46044}"/>
                </a:ext>
              </a:extLst>
            </p:cNvPr>
            <p:cNvSpPr txBox="1"/>
            <p:nvPr/>
          </p:nvSpPr>
          <p:spPr>
            <a:xfrm>
              <a:off x="3533754" y="856152"/>
              <a:ext cx="255600" cy="2628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/>
                <a:t>a</a:t>
              </a:r>
              <a:endParaRPr lang="fr-FR" dirty="0"/>
            </a:p>
          </p:txBody>
        </p:sp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1A04CEB7-6181-5CC8-8378-A31F7E4431B6}"/>
                </a:ext>
              </a:extLst>
            </p:cNvPr>
            <p:cNvSpPr txBox="1"/>
            <p:nvPr/>
          </p:nvSpPr>
          <p:spPr>
            <a:xfrm>
              <a:off x="6271157" y="850797"/>
              <a:ext cx="255600" cy="2628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/>
                <a:t>b</a:t>
              </a:r>
              <a:endParaRPr lang="fr-FR"/>
            </a:p>
          </p:txBody>
        </p:sp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00153BC5-5E95-AC0B-9B2A-84F3C76109B5}"/>
                </a:ext>
              </a:extLst>
            </p:cNvPr>
            <p:cNvSpPr txBox="1"/>
            <p:nvPr/>
          </p:nvSpPr>
          <p:spPr>
            <a:xfrm>
              <a:off x="3533756" y="2625317"/>
              <a:ext cx="255600" cy="2628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/>
                <a:t>c</a:t>
              </a:r>
              <a:endParaRPr lang="fr-FR"/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7F62F1C0-A07F-AC03-B1B3-0F625E7C4555}"/>
                </a:ext>
              </a:extLst>
            </p:cNvPr>
            <p:cNvSpPr txBox="1"/>
            <p:nvPr/>
          </p:nvSpPr>
          <p:spPr>
            <a:xfrm>
              <a:off x="6271159" y="2626588"/>
              <a:ext cx="255600" cy="2628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/>
                <a:t>d</a:t>
              </a:r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4031056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7E8BDB8-51F1-E9BE-EB04-776CA982676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e 11">
            <a:extLst>
              <a:ext uri="{FF2B5EF4-FFF2-40B4-BE49-F238E27FC236}">
                <a16:creationId xmlns:a16="http://schemas.microsoft.com/office/drawing/2014/main" id="{37A7B74F-B6AC-5FE7-1B5B-ADBC33CAEA07}"/>
              </a:ext>
            </a:extLst>
          </p:cNvPr>
          <p:cNvGrpSpPr/>
          <p:nvPr/>
        </p:nvGrpSpPr>
        <p:grpSpPr>
          <a:xfrm>
            <a:off x="3504602" y="1667948"/>
            <a:ext cx="5756910" cy="3070043"/>
            <a:chOff x="3504602" y="1667948"/>
            <a:chExt cx="5756910" cy="3070043"/>
          </a:xfrm>
        </p:grpSpPr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33BA3D9D-0142-BD62-3D39-457CB2D12183}"/>
                </a:ext>
              </a:extLst>
            </p:cNvPr>
            <p:cNvSpPr txBox="1"/>
            <p:nvPr/>
          </p:nvSpPr>
          <p:spPr>
            <a:xfrm>
              <a:off x="3504602" y="1875669"/>
              <a:ext cx="5756910" cy="28623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2 : Morton &amp; Griffith score [32]</a:t>
              </a:r>
            </a:p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score is determined by summing up five items, assessed on a scale of 0 to 3, based on observations of five different clinical criteria:</a:t>
              </a:r>
            </a:p>
            <a:p>
              <a:pPr>
                <a:buFont typeface="Arial" panose="020B0604020202020204" pitchFamily="34" charset="0"/>
                <a:buChar char="•"/>
              </a:pPr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ysical appearance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</a:t>
              </a:r>
              <a:b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rmal coat = 0 / Dirty coat = 1 / Ruffled coat = 2 / Ruffled coat + abnormal posture = 3</a:t>
              </a:r>
            </a:p>
            <a:p>
              <a:pPr>
                <a:buFont typeface="Arial" panose="020B0604020202020204" pitchFamily="34" charset="0"/>
                <a:buChar char="•"/>
              </a:pPr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imal weight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</a:t>
              </a:r>
              <a:b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changed = 0 / 5% weight loss = 1 / 10% weight loss = 2 / &gt;15% weight loss or lack of feeding = 3</a:t>
              </a:r>
            </a:p>
            <a:p>
              <a:pPr>
                <a:buFont typeface="Arial" panose="020B0604020202020204" pitchFamily="34" charset="0"/>
                <a:buChar char="•"/>
              </a:pPr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piratory rate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</a:t>
              </a:r>
              <a:b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changed = 0 / Altered by 10% = 1 / Increased by 10–50% = 2 / &gt;50% = 3</a:t>
              </a:r>
            </a:p>
            <a:p>
              <a:pPr>
                <a:buFont typeface="Arial" panose="020B0604020202020204" pitchFamily="34" charset="0"/>
                <a:buChar char="•"/>
              </a:pPr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ponse to external stimuli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</a:t>
              </a:r>
              <a:b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rmal = 0 / Weak = 1 / Withdrawal = 2 / Aggression or unresponsiveness = 3</a:t>
              </a:r>
            </a:p>
            <a:p>
              <a:pPr>
                <a:buFont typeface="Arial" panose="020B0604020202020204" pitchFamily="34" charset="0"/>
                <a:buChar char="•"/>
              </a:pPr>
              <a:r>
                <a:rPr lang="en-GB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ehavioral</a:t>
              </a:r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hanges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</a:t>
              </a:r>
              <a:b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rmal = 0 / Minor = 1 / Abnormal = 2 / Self-mutilation or vocalisation = 3</a:t>
              </a:r>
            </a:p>
            <a:p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ore 0–3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Normal monitoring (twice daily for 72 hours, then once daily).</a:t>
              </a:r>
            </a:p>
            <a:p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ore 4–6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Increased monitoring (twice daily).</a:t>
              </a:r>
            </a:p>
            <a:p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ore 7–8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Pain management.</a:t>
              </a:r>
            </a:p>
            <a:p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ore 9–15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Excessive pain—euthanasia to be considered.</a:t>
              </a:r>
            </a:p>
          </p:txBody>
        </p:sp>
        <p:grpSp>
          <p:nvGrpSpPr>
            <p:cNvPr id="21" name="Groupe 20">
              <a:extLst>
                <a:ext uri="{FF2B5EF4-FFF2-40B4-BE49-F238E27FC236}">
                  <a16:creationId xmlns:a16="http://schemas.microsoft.com/office/drawing/2014/main" id="{D7236293-78A7-8317-0FF8-7A341745F73D}"/>
                </a:ext>
              </a:extLst>
            </p:cNvPr>
            <p:cNvGrpSpPr/>
            <p:nvPr/>
          </p:nvGrpSpPr>
          <p:grpSpPr>
            <a:xfrm>
              <a:off x="4187450" y="1667948"/>
              <a:ext cx="3148944" cy="1993919"/>
              <a:chOff x="4187450" y="1667948"/>
              <a:chExt cx="3148944" cy="1993919"/>
            </a:xfrm>
          </p:grpSpPr>
          <p:cxnSp>
            <p:nvCxnSpPr>
              <p:cNvPr id="3" name="Connecteur droit avec flèche 2">
                <a:extLst>
                  <a:ext uri="{FF2B5EF4-FFF2-40B4-BE49-F238E27FC236}">
                    <a16:creationId xmlns:a16="http://schemas.microsoft.com/office/drawing/2014/main" id="{18996823-C120-2211-7A5F-7B51170B999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996975" y="1715638"/>
                <a:ext cx="675163" cy="0"/>
              </a:xfrm>
              <a:prstGeom prst="straightConnector1">
                <a:avLst/>
              </a:prstGeom>
              <a:ln w="2540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Connecteur droit avec flèche 15">
                <a:extLst>
                  <a:ext uri="{FF2B5EF4-FFF2-40B4-BE49-F238E27FC236}">
                    <a16:creationId xmlns:a16="http://schemas.microsoft.com/office/drawing/2014/main" id="{2F6C00A8-054C-B18A-F8AA-BCADF58C8D7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700836" y="1667948"/>
                <a:ext cx="635558" cy="0"/>
              </a:xfrm>
              <a:prstGeom prst="straightConnector1">
                <a:avLst/>
              </a:prstGeom>
              <a:ln w="2540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Connecteur droit avec flèche 17">
                <a:extLst>
                  <a:ext uri="{FF2B5EF4-FFF2-40B4-BE49-F238E27FC236}">
                    <a16:creationId xmlns:a16="http://schemas.microsoft.com/office/drawing/2014/main" id="{2030A1CA-B0D6-65BF-A223-C0D47492F2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87450" y="3640601"/>
                <a:ext cx="635558" cy="0"/>
              </a:xfrm>
              <a:prstGeom prst="straightConnector1">
                <a:avLst/>
              </a:prstGeom>
              <a:ln w="2540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Connecteur droit avec flèche 18">
                <a:extLst>
                  <a:ext uri="{FF2B5EF4-FFF2-40B4-BE49-F238E27FC236}">
                    <a16:creationId xmlns:a16="http://schemas.microsoft.com/office/drawing/2014/main" id="{83D0DFA9-186A-4023-3848-21486C36168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383057" y="3661867"/>
                <a:ext cx="635558" cy="0"/>
              </a:xfrm>
              <a:prstGeom prst="straightConnector1">
                <a:avLst/>
              </a:prstGeom>
              <a:ln w="2540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42866061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4F3BDD3-ACB1-FBEC-99EC-EE6B348154D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e 14">
            <a:extLst>
              <a:ext uri="{FF2B5EF4-FFF2-40B4-BE49-F238E27FC236}">
                <a16:creationId xmlns:a16="http://schemas.microsoft.com/office/drawing/2014/main" id="{AE83905E-735E-4D27-BC7B-769726F41DAA}"/>
              </a:ext>
            </a:extLst>
          </p:cNvPr>
          <p:cNvGrpSpPr/>
          <p:nvPr/>
        </p:nvGrpSpPr>
        <p:grpSpPr>
          <a:xfrm>
            <a:off x="3429000" y="854831"/>
            <a:ext cx="5861664" cy="4474901"/>
            <a:chOff x="3429000" y="854831"/>
            <a:chExt cx="5861664" cy="4474901"/>
          </a:xfrm>
        </p:grpSpPr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BB09B6BB-E316-AAD2-5A45-D5B66166B2F5}"/>
                </a:ext>
              </a:extLst>
            </p:cNvPr>
            <p:cNvSpPr txBox="1"/>
            <p:nvPr/>
          </p:nvSpPr>
          <p:spPr>
            <a:xfrm>
              <a:off x="3533754" y="4314069"/>
              <a:ext cx="5756910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3 : </a:t>
              </a:r>
              <a:r>
                <a:rPr lang="en-GB" sz="10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weight of the rats over time after the first surgical procedure</a:t>
              </a:r>
              <a:r>
                <a:rPr lang="en-GB" sz="10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  <a:p>
              <a:r>
                <a:rPr lang="en-GB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he values are represented by means, median, and quartile of the respective conditions during the follow-up:</a:t>
              </a:r>
            </a:p>
            <a:p>
              <a:r>
                <a:rPr lang="en-GB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Green: Rats with osteotomy and bone defect left empty; Grey: Rats with osteotomy and bone defect filled with</a:t>
              </a:r>
              <a:r>
                <a:rPr lang="en-GB" sz="10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MMA; Yellow: Rats with osteotomy and bone defect filled with syngeneic graft; Red; Rats with osteotomy and bone defect filled with Bioglass® biomaterial. A weight loss of 9.2 ± 8.3 g was recorded over 6.9 ± 7.7 days with</a:t>
              </a:r>
              <a:r>
                <a:rPr lang="en-GB" sz="10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n average time to recover the initial value of 11.8 ± 11.2 days.</a:t>
              </a:r>
            </a:p>
          </p:txBody>
        </p:sp>
        <p:pic>
          <p:nvPicPr>
            <p:cNvPr id="14" name="Image 13">
              <a:extLst>
                <a:ext uri="{FF2B5EF4-FFF2-40B4-BE49-F238E27FC236}">
                  <a16:creationId xmlns:a16="http://schemas.microsoft.com/office/drawing/2014/main" id="{57C16F39-8B4E-709E-2ACB-010A4D7A81B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29000" y="854831"/>
              <a:ext cx="5334000" cy="33782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9059924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4FBA607-6D26-0A7A-C4FD-1796FBE66FA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>
            <a:extLst>
              <a:ext uri="{FF2B5EF4-FFF2-40B4-BE49-F238E27FC236}">
                <a16:creationId xmlns:a16="http://schemas.microsoft.com/office/drawing/2014/main" id="{3A716893-3BB9-60E3-6C99-8200FF7BF83D}"/>
              </a:ext>
            </a:extLst>
          </p:cNvPr>
          <p:cNvGrpSpPr/>
          <p:nvPr/>
        </p:nvGrpSpPr>
        <p:grpSpPr>
          <a:xfrm>
            <a:off x="3524864" y="1370704"/>
            <a:ext cx="5765800" cy="3959028"/>
            <a:chOff x="3524864" y="1370704"/>
            <a:chExt cx="5765800" cy="3959028"/>
          </a:xfrm>
        </p:grpSpPr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5ADBB111-E0DA-A49C-48AC-06FB2C486FC7}"/>
                </a:ext>
              </a:extLst>
            </p:cNvPr>
            <p:cNvSpPr txBox="1"/>
            <p:nvPr/>
          </p:nvSpPr>
          <p:spPr>
            <a:xfrm>
              <a:off x="3533754" y="4314069"/>
              <a:ext cx="5756910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4 : </a:t>
              </a:r>
              <a:r>
                <a:rPr lang="en-GB" sz="10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weight of the rats over time after the second surgical procedure</a:t>
              </a:r>
              <a:r>
                <a:rPr lang="en-GB" sz="10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  <a:p>
              <a:r>
                <a:rPr lang="en-GB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he values are represented by means, median, and quartile of the respective conditions during the follow-up:</a:t>
              </a:r>
            </a:p>
            <a:p>
              <a:r>
                <a:rPr lang="en-GB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Yellow: Second surgery step with bone defect filled by syngeneic graft; Green: Second surgery step with bone</a:t>
              </a:r>
              <a:r>
                <a:rPr lang="en-GB" sz="10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efect left empty; Red: Second surgery step with defect filled with Bioglass® biomaterial. A weight loss of 15.5 ± 12.8 g was recorded over 5.5 ± 6.7 days and an average time of 13.0 ± 15.1 days was required to recover the initial weight</a:t>
              </a:r>
            </a:p>
          </p:txBody>
        </p:sp>
        <p:pic>
          <p:nvPicPr>
            <p:cNvPr id="3" name="Image 2">
              <a:extLst>
                <a:ext uri="{FF2B5EF4-FFF2-40B4-BE49-F238E27FC236}">
                  <a16:creationId xmlns:a16="http://schemas.microsoft.com/office/drawing/2014/main" id="{05573890-8730-5EFE-52B0-083D4D27C3C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524864" y="1370704"/>
              <a:ext cx="5765800" cy="28194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3491313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7F9B4C6-6EAD-CF26-3C67-AEA92AA70AC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e 5">
            <a:extLst>
              <a:ext uri="{FF2B5EF4-FFF2-40B4-BE49-F238E27FC236}">
                <a16:creationId xmlns:a16="http://schemas.microsoft.com/office/drawing/2014/main" id="{94DD0F75-13E7-9131-88B7-970B05B17285}"/>
              </a:ext>
            </a:extLst>
          </p:cNvPr>
          <p:cNvGrpSpPr/>
          <p:nvPr/>
        </p:nvGrpSpPr>
        <p:grpSpPr>
          <a:xfrm>
            <a:off x="3533754" y="570260"/>
            <a:ext cx="5756910" cy="5447963"/>
            <a:chOff x="3533754" y="570260"/>
            <a:chExt cx="5756910" cy="5447963"/>
          </a:xfrm>
        </p:grpSpPr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320E3CE8-2D08-95BD-9A27-403E91C3C9FC}"/>
                </a:ext>
              </a:extLst>
            </p:cNvPr>
            <p:cNvSpPr txBox="1"/>
            <p:nvPr/>
          </p:nvSpPr>
          <p:spPr>
            <a:xfrm>
              <a:off x="3533754" y="5002560"/>
              <a:ext cx="5756910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5 : </a:t>
              </a:r>
              <a:r>
                <a:rPr lang="en-GB" sz="10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orton &amp; Griffith score [32] after the first surgical procedure</a:t>
              </a:r>
              <a:r>
                <a:rPr lang="fr-FR" sz="10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GB" sz="10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he values are represented by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eans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edian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, and quartile of the respective conditions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uring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he follow-up:</a:t>
              </a:r>
            </a:p>
            <a:p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Green: Rats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ith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teotomy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one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efect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eft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mpty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; Grey: Rats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ith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teotomy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one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efect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illed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ith</a:t>
              </a:r>
              <a:r>
                <a:rPr lang="fr-FR" sz="10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MMA; Yellow: Rats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ith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teotomy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one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efect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illed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ith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yngeneic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graft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; Red; Rats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ith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teotomy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and</a:t>
              </a:r>
              <a:r>
                <a:rPr lang="fr-FR" sz="10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one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efect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illed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ith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ioglass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®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iomaterial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. The score on the first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ostoperative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ay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veraged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4 ± 2,</a:t>
              </a:r>
              <a:r>
                <a:rPr lang="fr-FR" sz="10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ecreasing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o a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zero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alue by 5 </a:t>
              </a:r>
              <a:r>
                <a:rPr lang="fr-FR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eeks</a:t>
              </a:r>
              <a:r>
                <a:rPr lang="fr-FR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</a:p>
          </p:txBody>
        </p:sp>
        <p:pic>
          <p:nvPicPr>
            <p:cNvPr id="5" name="Image 4" descr="Une image contenant diagramme, Tracé, ligne, conception&#10;&#10;Description générée automatiquement">
              <a:extLst>
                <a:ext uri="{FF2B5EF4-FFF2-40B4-BE49-F238E27FC236}">
                  <a16:creationId xmlns:a16="http://schemas.microsoft.com/office/drawing/2014/main" id="{E3641F87-C2C5-C926-D4C3-202BCE1FA05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533754" y="570260"/>
              <a:ext cx="4813300" cy="44323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8743948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090F014-968C-3753-C59C-9998BCD3791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>
            <a:extLst>
              <a:ext uri="{FF2B5EF4-FFF2-40B4-BE49-F238E27FC236}">
                <a16:creationId xmlns:a16="http://schemas.microsoft.com/office/drawing/2014/main" id="{563AE884-AE51-99B7-E76E-3F123B313A0D}"/>
              </a:ext>
            </a:extLst>
          </p:cNvPr>
          <p:cNvGrpSpPr/>
          <p:nvPr/>
        </p:nvGrpSpPr>
        <p:grpSpPr>
          <a:xfrm>
            <a:off x="3217424" y="570260"/>
            <a:ext cx="6073240" cy="5294074"/>
            <a:chOff x="3217424" y="570260"/>
            <a:chExt cx="6073240" cy="5294074"/>
          </a:xfrm>
        </p:grpSpPr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5ADE8FA9-100F-2DDC-CCEB-369C01D93426}"/>
                </a:ext>
              </a:extLst>
            </p:cNvPr>
            <p:cNvSpPr txBox="1"/>
            <p:nvPr/>
          </p:nvSpPr>
          <p:spPr>
            <a:xfrm>
              <a:off x="3533754" y="5002560"/>
              <a:ext cx="5756910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6 : </a:t>
              </a:r>
              <a:r>
                <a:rPr lang="en-GB" sz="10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orton &amp; Griffith score [32] after the </a:t>
              </a:r>
              <a:r>
                <a:rPr lang="en-GB" sz="10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econd</a:t>
              </a:r>
              <a:r>
                <a:rPr lang="en-GB" sz="10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surgical procedure</a:t>
              </a:r>
              <a:r>
                <a:rPr lang="fr-FR" sz="10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GB" sz="10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GB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he values are represented by means, median, and quartile of the respective conditions during the follow-up:</a:t>
              </a:r>
            </a:p>
            <a:p>
              <a:r>
                <a:rPr lang="en-GB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Yellow: Second surgery step with bone defect filled by syngeneic graft; Green: Second surgery step with bone</a:t>
              </a:r>
              <a:r>
                <a:rPr lang="en-GB" sz="10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efect left empty; Red: Second surgery step with defect filled with Bioglass® biomaterial. The score on the first postoperative day averaged 6, decreasing to a zero value for all subjects by six weeks.</a:t>
              </a:r>
            </a:p>
          </p:txBody>
        </p:sp>
        <p:pic>
          <p:nvPicPr>
            <p:cNvPr id="3" name="Image 2" descr="Une image contenant diagramme, ligne, Tracé, conception&#10;&#10;Description générée automatiquement">
              <a:extLst>
                <a:ext uri="{FF2B5EF4-FFF2-40B4-BE49-F238E27FC236}">
                  <a16:creationId xmlns:a16="http://schemas.microsoft.com/office/drawing/2014/main" id="{FF72A818-0BFB-5C87-BBC3-A88142187C1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17424" y="570260"/>
              <a:ext cx="5156200" cy="44323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5505286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F623864-F643-B736-CEB8-62B207CF11B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e 24">
            <a:extLst>
              <a:ext uri="{FF2B5EF4-FFF2-40B4-BE49-F238E27FC236}">
                <a16:creationId xmlns:a16="http://schemas.microsoft.com/office/drawing/2014/main" id="{4C77FEC3-8F7E-18EC-EAD1-36C84B326C3F}"/>
              </a:ext>
            </a:extLst>
          </p:cNvPr>
          <p:cNvGrpSpPr/>
          <p:nvPr/>
        </p:nvGrpSpPr>
        <p:grpSpPr>
          <a:xfrm>
            <a:off x="3533754" y="296474"/>
            <a:ext cx="5756910" cy="5910687"/>
            <a:chOff x="3533754" y="296474"/>
            <a:chExt cx="5756910" cy="5910687"/>
          </a:xfrm>
        </p:grpSpPr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9CFBCC3F-93D6-4F51-2E24-B8B6D2FE07F6}"/>
                </a:ext>
              </a:extLst>
            </p:cNvPr>
            <p:cNvSpPr txBox="1"/>
            <p:nvPr/>
          </p:nvSpPr>
          <p:spPr>
            <a:xfrm>
              <a:off x="3533754" y="5499275"/>
              <a:ext cx="5756910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7 : </a:t>
              </a:r>
              <a:r>
                <a:rPr lang="en-GB" sz="10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T radiological</a:t>
              </a:r>
              <a:r>
                <a:rPr lang="en-GB" sz="10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control after cutting procedures at 6 weeks</a:t>
              </a:r>
              <a:endParaRPr lang="en-GB" sz="10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 follow-up X-ray shows achieved consolidation with secondary displacement of the osteosynthesis material in all conditions. (a, b) : Rats with ball cutter osteotomies ; (c – e) : Rats with rotating saw osteotomies ; (f  -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: Rats with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iezotomy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steotomies</a:t>
              </a:r>
              <a:endParaRPr lang="en-GB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" name="Groupe 4">
              <a:extLst>
                <a:ext uri="{FF2B5EF4-FFF2-40B4-BE49-F238E27FC236}">
                  <a16:creationId xmlns:a16="http://schemas.microsoft.com/office/drawing/2014/main" id="{A085CC37-9195-D177-EBA4-A3755AB3DD24}"/>
                </a:ext>
              </a:extLst>
            </p:cNvPr>
            <p:cNvGrpSpPr/>
            <p:nvPr/>
          </p:nvGrpSpPr>
          <p:grpSpPr>
            <a:xfrm>
              <a:off x="3639139" y="296474"/>
              <a:ext cx="3540595" cy="5107407"/>
              <a:chOff x="7258632" y="231329"/>
              <a:chExt cx="3540595" cy="5107407"/>
            </a:xfrm>
          </p:grpSpPr>
          <p:pic>
            <p:nvPicPr>
              <p:cNvPr id="6" name="Image 5" descr="Une image contenant film radiographique, Imagerie médicale, médical, Rayon X&#10;&#10;Description générée automatiquement">
                <a:extLst>
                  <a:ext uri="{FF2B5EF4-FFF2-40B4-BE49-F238E27FC236}">
                    <a16:creationId xmlns:a16="http://schemas.microsoft.com/office/drawing/2014/main" id="{A23F0865-4B3A-E3D0-684B-3B8679E40AA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7258936" y="252112"/>
                <a:ext cx="1117600" cy="1612900"/>
              </a:xfrm>
              <a:prstGeom prst="rect">
                <a:avLst/>
              </a:prstGeom>
            </p:spPr>
          </p:pic>
          <p:pic>
            <p:nvPicPr>
              <p:cNvPr id="7" name="Image 6" descr="Une image contenant film radiographique, noir, Rayon X, noir et blanc&#10;&#10;Description générée automatiquement">
                <a:extLst>
                  <a:ext uri="{FF2B5EF4-FFF2-40B4-BE49-F238E27FC236}">
                    <a16:creationId xmlns:a16="http://schemas.microsoft.com/office/drawing/2014/main" id="{89347924-5884-5604-2C33-4B469D90797E}"/>
                  </a:ext>
                </a:extLst>
              </p:cNvPr>
              <p:cNvPicPr>
                <a:picLocks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8471881" y="246723"/>
                <a:ext cx="1116000" cy="1612800"/>
              </a:xfrm>
              <a:prstGeom prst="rect">
                <a:avLst/>
              </a:prstGeom>
            </p:spPr>
          </p:pic>
          <p:pic>
            <p:nvPicPr>
              <p:cNvPr id="8" name="Image 7" descr="Une image contenant film radiographique, noir, Imagerie médicale, Rayon X&#10;&#10;Description générée automatiquement">
                <a:extLst>
                  <a:ext uri="{FF2B5EF4-FFF2-40B4-BE49-F238E27FC236}">
                    <a16:creationId xmlns:a16="http://schemas.microsoft.com/office/drawing/2014/main" id="{E93CEC10-5A57-F865-EA20-12456C6DF674}"/>
                  </a:ext>
                </a:extLst>
              </p:cNvPr>
              <p:cNvPicPr>
                <a:picLocks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9683227" y="252112"/>
                <a:ext cx="1116000" cy="1612800"/>
              </a:xfrm>
              <a:prstGeom prst="rect">
                <a:avLst/>
              </a:prstGeom>
            </p:spPr>
          </p:pic>
          <p:pic>
            <p:nvPicPr>
              <p:cNvPr id="9" name="Image 8" descr="Une image contenant film radiographique, Imagerie médicale, Rayon X, radiographie&#10;&#10;Description générée automatiquement">
                <a:extLst>
                  <a:ext uri="{FF2B5EF4-FFF2-40B4-BE49-F238E27FC236}">
                    <a16:creationId xmlns:a16="http://schemas.microsoft.com/office/drawing/2014/main" id="{15385614-E51E-7B55-13F0-1F488AA9C1BC}"/>
                  </a:ext>
                </a:extLst>
              </p:cNvPr>
              <p:cNvPicPr>
                <a:picLocks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7263363" y="1989074"/>
                <a:ext cx="1116000" cy="1612800"/>
              </a:xfrm>
              <a:prstGeom prst="rect">
                <a:avLst/>
              </a:prstGeom>
            </p:spPr>
          </p:pic>
          <p:pic>
            <p:nvPicPr>
              <p:cNvPr id="10" name="Image 9" descr="Une image contenant noir, trouble, noir et blanc, film radiographique&#10;&#10;Description générée automatiquement">
                <a:extLst>
                  <a:ext uri="{FF2B5EF4-FFF2-40B4-BE49-F238E27FC236}">
                    <a16:creationId xmlns:a16="http://schemas.microsoft.com/office/drawing/2014/main" id="{45522480-E43F-FD0C-CF40-42BC0F23B5BE}"/>
                  </a:ext>
                </a:extLst>
              </p:cNvPr>
              <p:cNvPicPr>
                <a:picLocks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471881" y="1989074"/>
                <a:ext cx="1116000" cy="1612800"/>
              </a:xfrm>
              <a:prstGeom prst="rect">
                <a:avLst/>
              </a:prstGeom>
            </p:spPr>
          </p:pic>
          <p:pic>
            <p:nvPicPr>
              <p:cNvPr id="12" name="Image 11" descr="Une image contenant film radiographique, Imagerie médicale, Rayon X, radiographie&#10;&#10;Description générée automatiquement">
                <a:extLst>
                  <a:ext uri="{FF2B5EF4-FFF2-40B4-BE49-F238E27FC236}">
                    <a16:creationId xmlns:a16="http://schemas.microsoft.com/office/drawing/2014/main" id="{C92E6A06-1311-1AE3-8F52-AE07545C1F80}"/>
                  </a:ext>
                </a:extLst>
              </p:cNvPr>
              <p:cNvPicPr>
                <a:picLocks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9683227" y="1989074"/>
                <a:ext cx="1116000" cy="1612800"/>
              </a:xfrm>
              <a:prstGeom prst="rect">
                <a:avLst/>
              </a:prstGeom>
            </p:spPr>
          </p:pic>
          <p:pic>
            <p:nvPicPr>
              <p:cNvPr id="13" name="Image 12" descr="Une image contenant film radiographique, Rayon X, Imagerie médicale, radiographie&#10;&#10;Description générée automatiquement">
                <a:extLst>
                  <a:ext uri="{FF2B5EF4-FFF2-40B4-BE49-F238E27FC236}">
                    <a16:creationId xmlns:a16="http://schemas.microsoft.com/office/drawing/2014/main" id="{A0616F28-8B1A-6520-D59A-4D54DF1EDE0F}"/>
                  </a:ext>
                </a:extLst>
              </p:cNvPr>
              <p:cNvPicPr>
                <a:picLocks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7260536" y="3725936"/>
                <a:ext cx="1116000" cy="1612800"/>
              </a:xfrm>
              <a:prstGeom prst="rect">
                <a:avLst/>
              </a:prstGeom>
            </p:spPr>
          </p:pic>
          <p:pic>
            <p:nvPicPr>
              <p:cNvPr id="14" name="Image 13" descr="Une image contenant film radiographique, Imagerie médicale, Rayon X, radiographie&#10;&#10;Description générée automatiquement">
                <a:extLst>
                  <a:ext uri="{FF2B5EF4-FFF2-40B4-BE49-F238E27FC236}">
                    <a16:creationId xmlns:a16="http://schemas.microsoft.com/office/drawing/2014/main" id="{0BCB48AA-09A7-F527-5DDF-4B75990834AC}"/>
                  </a:ext>
                </a:extLst>
              </p:cNvPr>
              <p:cNvPicPr>
                <a:picLocks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8471881" y="3725936"/>
                <a:ext cx="1116000" cy="1612800"/>
              </a:xfrm>
              <a:prstGeom prst="rect">
                <a:avLst/>
              </a:prstGeom>
            </p:spPr>
          </p:pic>
          <p:pic>
            <p:nvPicPr>
              <p:cNvPr id="15" name="Image 14" descr="Une image contenant film radiographique, noir, capture d’écran, Imagerie médicale&#10;&#10;Description générée automatiquement">
                <a:extLst>
                  <a:ext uri="{FF2B5EF4-FFF2-40B4-BE49-F238E27FC236}">
                    <a16:creationId xmlns:a16="http://schemas.microsoft.com/office/drawing/2014/main" id="{96E051DB-04B2-796F-2FCD-00FAE1B371D5}"/>
                  </a:ext>
                </a:extLst>
              </p:cNvPr>
              <p:cNvPicPr>
                <a:picLocks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9683227" y="3725936"/>
                <a:ext cx="1116000" cy="1612800"/>
              </a:xfrm>
              <a:prstGeom prst="rect">
                <a:avLst/>
              </a:prstGeom>
            </p:spPr>
          </p:pic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DB381743-3B7C-61E7-ECAE-9716DB6BB947}"/>
                  </a:ext>
                </a:extLst>
              </p:cNvPr>
              <p:cNvSpPr/>
              <p:nvPr/>
            </p:nvSpPr>
            <p:spPr>
              <a:xfrm>
                <a:off x="7258632" y="238466"/>
                <a:ext cx="250361" cy="26278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200" dirty="0">
                    <a:solidFill>
                      <a:schemeClr val="tx1"/>
                    </a:solidFill>
                  </a:rPr>
                  <a:t>a</a:t>
                </a:r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EF064E90-B7F1-C09B-F2C4-50D3392B0C9E}"/>
                  </a:ext>
                </a:extLst>
              </p:cNvPr>
              <p:cNvSpPr/>
              <p:nvPr/>
            </p:nvSpPr>
            <p:spPr>
              <a:xfrm>
                <a:off x="8452117" y="231329"/>
                <a:ext cx="250361" cy="26278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200" dirty="0">
                    <a:solidFill>
                      <a:schemeClr val="tx1"/>
                    </a:solidFill>
                  </a:rPr>
                  <a:t>b</a:t>
                </a:r>
              </a:p>
            </p:txBody>
          </p:sp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D0778F42-26B5-2611-53C2-311CA3DA6553}"/>
                  </a:ext>
                </a:extLst>
              </p:cNvPr>
              <p:cNvSpPr/>
              <p:nvPr/>
            </p:nvSpPr>
            <p:spPr>
              <a:xfrm>
                <a:off x="9679904" y="236756"/>
                <a:ext cx="250361" cy="26278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200" dirty="0">
                    <a:solidFill>
                      <a:schemeClr val="tx1"/>
                    </a:solidFill>
                  </a:rPr>
                  <a:t>c</a:t>
                </a:r>
              </a:p>
            </p:txBody>
          </p:sp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85666B6B-FDB7-E5FE-F23F-5F90D5555DDD}"/>
                  </a:ext>
                </a:extLst>
              </p:cNvPr>
              <p:cNvSpPr/>
              <p:nvPr/>
            </p:nvSpPr>
            <p:spPr>
              <a:xfrm>
                <a:off x="7258632" y="1981185"/>
                <a:ext cx="250361" cy="26278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200" dirty="0">
                    <a:solidFill>
                      <a:schemeClr val="tx1"/>
                    </a:solidFill>
                  </a:rPr>
                  <a:t>d</a:t>
                </a:r>
              </a:p>
            </p:txBody>
          </p:sp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FC28640A-1DA6-43F3-EBFF-5EC70B45D9B1}"/>
                  </a:ext>
                </a:extLst>
              </p:cNvPr>
              <p:cNvSpPr/>
              <p:nvPr/>
            </p:nvSpPr>
            <p:spPr>
              <a:xfrm>
                <a:off x="8463406" y="1985337"/>
                <a:ext cx="250361" cy="26278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200" dirty="0">
                    <a:solidFill>
                      <a:schemeClr val="tx1"/>
                    </a:solidFill>
                  </a:rPr>
                  <a:t>e</a:t>
                </a:r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E35197D8-3DBB-940C-45E6-282D02994A75}"/>
                  </a:ext>
                </a:extLst>
              </p:cNvPr>
              <p:cNvSpPr/>
              <p:nvPr/>
            </p:nvSpPr>
            <p:spPr>
              <a:xfrm>
                <a:off x="9679904" y="1990764"/>
                <a:ext cx="250361" cy="26278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200" dirty="0">
                    <a:solidFill>
                      <a:schemeClr val="tx1"/>
                    </a:solidFill>
                  </a:rPr>
                  <a:t>f</a:t>
                </a:r>
              </a:p>
            </p:txBody>
          </p:sp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53109FA1-DEE2-CE67-4135-F87B7192F28F}"/>
                  </a:ext>
                </a:extLst>
              </p:cNvPr>
              <p:cNvSpPr/>
              <p:nvPr/>
            </p:nvSpPr>
            <p:spPr>
              <a:xfrm>
                <a:off x="7258632" y="3722211"/>
                <a:ext cx="250361" cy="26278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200" dirty="0">
                    <a:solidFill>
                      <a:schemeClr val="tx1"/>
                    </a:solidFill>
                  </a:rPr>
                  <a:t>g</a:t>
                </a:r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6AFF3D61-FD65-975C-E036-DA85F1BC325D}"/>
                  </a:ext>
                </a:extLst>
              </p:cNvPr>
              <p:cNvSpPr/>
              <p:nvPr/>
            </p:nvSpPr>
            <p:spPr>
              <a:xfrm>
                <a:off x="8463406" y="3726363"/>
                <a:ext cx="250361" cy="26278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200" dirty="0">
                    <a:solidFill>
                      <a:schemeClr val="tx1"/>
                    </a:solidFill>
                  </a:rPr>
                  <a:t>h</a:t>
                </a:r>
              </a:p>
            </p:txBody>
          </p:sp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80D99406-DAC5-7215-B2A4-434BDC823189}"/>
                  </a:ext>
                </a:extLst>
              </p:cNvPr>
              <p:cNvSpPr/>
              <p:nvPr/>
            </p:nvSpPr>
            <p:spPr>
              <a:xfrm>
                <a:off x="9679904" y="3726363"/>
                <a:ext cx="250361" cy="26278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200" dirty="0">
                    <a:solidFill>
                      <a:schemeClr val="tx1"/>
                    </a:solidFill>
                  </a:rPr>
                  <a:t>i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74485357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45F94F0-94DE-8BE6-19CF-EFBB088D801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e 21">
            <a:extLst>
              <a:ext uri="{FF2B5EF4-FFF2-40B4-BE49-F238E27FC236}">
                <a16:creationId xmlns:a16="http://schemas.microsoft.com/office/drawing/2014/main" id="{D87AED1F-F4E2-2FF5-7169-D81D93A9AF43}"/>
              </a:ext>
            </a:extLst>
          </p:cNvPr>
          <p:cNvGrpSpPr/>
          <p:nvPr/>
        </p:nvGrpSpPr>
        <p:grpSpPr>
          <a:xfrm>
            <a:off x="3289527" y="891442"/>
            <a:ext cx="5612946" cy="4942386"/>
            <a:chOff x="3289527" y="891442"/>
            <a:chExt cx="5612946" cy="4942386"/>
          </a:xfrm>
        </p:grpSpPr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591D3C4F-26B8-3508-E651-4FC773B81855}"/>
                </a:ext>
              </a:extLst>
            </p:cNvPr>
            <p:cNvSpPr txBox="1"/>
            <p:nvPr/>
          </p:nvSpPr>
          <p:spPr>
            <a:xfrm>
              <a:off x="3289527" y="4972054"/>
              <a:ext cx="5612946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8 : CT radiological control after </a:t>
              </a:r>
              <a:r>
                <a:rPr lang="en-GB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iezotome</a:t>
              </a:r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steotomies with the two osteosynthesis devices at 6 weeks </a:t>
              </a:r>
            </a:p>
            <a:p>
              <a:r>
                <a:rPr lang="en-GB" sz="10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iezotome</a:t>
              </a:r>
              <a:r>
                <a:rPr lang="en-GB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osteotomies with a 4 mm bone defect with 2 plates and screws (MEDARTIS®):</a:t>
              </a:r>
            </a:p>
            <a:p>
              <a:r>
                <a:rPr lang="en-GB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a) 1 mm thick plate and 2 mm diameter screw: The material remains in place despite the critical defect</a:t>
              </a:r>
            </a:p>
            <a:p>
              <a:r>
                <a:rPr lang="en-GB" sz="1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b - e) 0,6 mm thick plate and 1,5 mm diameter screw. Examples of broken plate.</a:t>
              </a:r>
            </a:p>
          </p:txBody>
        </p:sp>
        <p:grpSp>
          <p:nvGrpSpPr>
            <p:cNvPr id="8" name="Groupe 7">
              <a:extLst>
                <a:ext uri="{FF2B5EF4-FFF2-40B4-BE49-F238E27FC236}">
                  <a16:creationId xmlns:a16="http://schemas.microsoft.com/office/drawing/2014/main" id="{3AC27EEC-5895-590A-95BB-82B4AF22E1AB}"/>
                </a:ext>
              </a:extLst>
            </p:cNvPr>
            <p:cNvGrpSpPr/>
            <p:nvPr/>
          </p:nvGrpSpPr>
          <p:grpSpPr>
            <a:xfrm>
              <a:off x="4457381" y="891442"/>
              <a:ext cx="3277237" cy="3960685"/>
              <a:chOff x="2818763" y="185642"/>
              <a:chExt cx="3277237" cy="3960685"/>
            </a:xfrm>
          </p:grpSpPr>
          <p:pic>
            <p:nvPicPr>
              <p:cNvPr id="9" name="Image 8" descr="Macintosh HD:Users:Rod:Desktop:Capture d’écran 2018-05-20 à 22.19.38.png">
                <a:extLst>
                  <a:ext uri="{FF2B5EF4-FFF2-40B4-BE49-F238E27FC236}">
                    <a16:creationId xmlns:a16="http://schemas.microsoft.com/office/drawing/2014/main" id="{586BB4EC-F6F6-1330-4DE1-84D60435653A}"/>
                  </a:ext>
                </a:extLst>
              </p:cNvPr>
              <p:cNvPicPr/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23000" contrast="33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392039" y="2196247"/>
                <a:ext cx="1015200" cy="1940400"/>
              </a:xfrm>
              <a:prstGeom prst="rect">
                <a:avLst/>
              </a:prstGeom>
              <a:noFill/>
              <a:ln>
                <a:solidFill>
                  <a:srgbClr val="000000"/>
                </a:solidFill>
              </a:ln>
            </p:spPr>
          </p:pic>
          <p:pic>
            <p:nvPicPr>
              <p:cNvPr id="10" name="Image 9" descr="Macintosh HD:Users:Rod:Desktop:Capture d’écran 2018-05-20 à 22.19.51.png">
                <a:extLst>
                  <a:ext uri="{FF2B5EF4-FFF2-40B4-BE49-F238E27FC236}">
                    <a16:creationId xmlns:a16="http://schemas.microsoft.com/office/drawing/2014/main" id="{327E8C73-631E-3D79-93DB-693A3804B3F1}"/>
                  </a:ext>
                </a:extLst>
              </p:cNvPr>
              <p:cNvPicPr/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27000" contrast="27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flipV="1">
                <a:off x="5080800" y="185971"/>
                <a:ext cx="1015200" cy="1940400"/>
              </a:xfrm>
              <a:prstGeom prst="rect">
                <a:avLst/>
              </a:prstGeom>
              <a:noFill/>
              <a:ln>
                <a:solidFill>
                  <a:srgbClr val="000000"/>
                </a:solidFill>
              </a:ln>
            </p:spPr>
          </p:pic>
          <p:grpSp>
            <p:nvGrpSpPr>
              <p:cNvPr id="12" name="Groupe 11">
                <a:extLst>
                  <a:ext uri="{FF2B5EF4-FFF2-40B4-BE49-F238E27FC236}">
                    <a16:creationId xmlns:a16="http://schemas.microsoft.com/office/drawing/2014/main" id="{87ACF1F9-29EB-CFA2-4078-A5E45C080F65}"/>
                  </a:ext>
                </a:extLst>
              </p:cNvPr>
              <p:cNvGrpSpPr/>
              <p:nvPr/>
            </p:nvGrpSpPr>
            <p:grpSpPr>
              <a:xfrm>
                <a:off x="2818763" y="185642"/>
                <a:ext cx="2715612" cy="3960685"/>
                <a:chOff x="2818763" y="185642"/>
                <a:chExt cx="2715612" cy="3960685"/>
              </a:xfrm>
            </p:grpSpPr>
            <p:pic>
              <p:nvPicPr>
                <p:cNvPr id="13" name="Image 12">
                  <a:extLst>
                    <a:ext uri="{FF2B5EF4-FFF2-40B4-BE49-F238E27FC236}">
                      <a16:creationId xmlns:a16="http://schemas.microsoft.com/office/drawing/2014/main" id="{B43AB379-B8F2-ACDA-E4B0-C091A7FE4F1B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40000" contrast="-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519645" y="2204497"/>
                  <a:ext cx="1014730" cy="1941830"/>
                </a:xfrm>
                <a:prstGeom prst="rect">
                  <a:avLst/>
                </a:prstGeom>
                <a:noFill/>
                <a:ln w="9525" cmpd="sng">
                  <a:solidFill>
                    <a:srgbClr val="000000"/>
                  </a:solidFill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14" name="Image 13">
                  <a:extLst>
                    <a:ext uri="{FF2B5EF4-FFF2-40B4-BE49-F238E27FC236}">
                      <a16:creationId xmlns:a16="http://schemas.microsoft.com/office/drawing/2014/main" id="{F59DF7BA-14CB-5193-60F1-399A0BD65164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8" cstate="print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brightnessContrast bright="4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954065" y="185971"/>
                  <a:ext cx="1014730" cy="1941830"/>
                </a:xfrm>
                <a:prstGeom prst="rect">
                  <a:avLst/>
                </a:prstGeom>
                <a:noFill/>
                <a:ln w="9525" cmpd="sng">
                  <a:solidFill>
                    <a:srgbClr val="000000"/>
                  </a:solidFill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15" name="Image 14">
                  <a:extLst>
                    <a:ext uri="{FF2B5EF4-FFF2-40B4-BE49-F238E27FC236}">
                      <a16:creationId xmlns:a16="http://schemas.microsoft.com/office/drawing/2014/main" id="{E39347DE-D2C3-7BBB-492C-E6984504843E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0" cstate="print">
                  <a:extLst>
                    <a:ext uri="{BEBA8EAE-BF5A-486C-A8C5-ECC9F3942E4B}">
                      <a14:imgProps xmlns:a14="http://schemas.microsoft.com/office/drawing/2010/main">
                        <a14:imgLayer r:embed="rId11">
                          <a14:imgEffect>
                            <a14:brightnessContrast bright="59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818763" y="187875"/>
                  <a:ext cx="1014730" cy="1939925"/>
                </a:xfrm>
                <a:prstGeom prst="rect">
                  <a:avLst/>
                </a:prstGeom>
                <a:noFill/>
                <a:ln>
                  <a:solidFill>
                    <a:srgbClr val="000000"/>
                  </a:solidFill>
                </a:ln>
              </p:spPr>
            </p:pic>
            <p:sp>
              <p:nvSpPr>
                <p:cNvPr id="16" name="Rectangle 15">
                  <a:extLst>
                    <a:ext uri="{FF2B5EF4-FFF2-40B4-BE49-F238E27FC236}">
                      <a16:creationId xmlns:a16="http://schemas.microsoft.com/office/drawing/2014/main" id="{C9B7E45E-9A4B-AECD-6C2E-E79D259F2D23}"/>
                    </a:ext>
                  </a:extLst>
                </p:cNvPr>
                <p:cNvSpPr/>
                <p:nvPr/>
              </p:nvSpPr>
              <p:spPr>
                <a:xfrm>
                  <a:off x="2818764" y="189391"/>
                  <a:ext cx="250361" cy="26278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fr-FR" sz="1200" dirty="0">
                      <a:solidFill>
                        <a:schemeClr val="tx1"/>
                      </a:solidFill>
                      <a:cs typeface="Calibri" panose="020F0502020204030204" pitchFamily="34" charset="0"/>
                    </a:rPr>
                    <a:t>a</a:t>
                  </a:r>
                </a:p>
              </p:txBody>
            </p:sp>
            <p:sp>
              <p:nvSpPr>
                <p:cNvPr id="17" name="Rectangle 16">
                  <a:extLst>
                    <a:ext uri="{FF2B5EF4-FFF2-40B4-BE49-F238E27FC236}">
                      <a16:creationId xmlns:a16="http://schemas.microsoft.com/office/drawing/2014/main" id="{469A84A1-50F2-BE5E-A42A-5D572D53A2B0}"/>
                    </a:ext>
                  </a:extLst>
                </p:cNvPr>
                <p:cNvSpPr/>
                <p:nvPr/>
              </p:nvSpPr>
              <p:spPr>
                <a:xfrm>
                  <a:off x="3954064" y="185642"/>
                  <a:ext cx="250361" cy="26278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fr-FR" sz="1200" dirty="0">
                      <a:solidFill>
                        <a:schemeClr val="tx1"/>
                      </a:solidFill>
                    </a:rPr>
                    <a:t>b</a:t>
                  </a:r>
                </a:p>
              </p:txBody>
            </p:sp>
            <p:sp>
              <p:nvSpPr>
                <p:cNvPr id="18" name="Rectangle 17">
                  <a:extLst>
                    <a:ext uri="{FF2B5EF4-FFF2-40B4-BE49-F238E27FC236}">
                      <a16:creationId xmlns:a16="http://schemas.microsoft.com/office/drawing/2014/main" id="{B9F42A0C-482F-561B-9653-20041AED79DC}"/>
                    </a:ext>
                  </a:extLst>
                </p:cNvPr>
                <p:cNvSpPr/>
                <p:nvPr/>
              </p:nvSpPr>
              <p:spPr>
                <a:xfrm>
                  <a:off x="3396178" y="2194859"/>
                  <a:ext cx="250361" cy="26278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fr-FR" sz="1200" dirty="0">
                      <a:solidFill>
                        <a:schemeClr val="tx1"/>
                      </a:solidFill>
                    </a:rPr>
                    <a:t>d</a:t>
                  </a:r>
                </a:p>
              </p:txBody>
            </p:sp>
            <p:sp>
              <p:nvSpPr>
                <p:cNvPr id="19" name="Rectangle 18">
                  <a:extLst>
                    <a:ext uri="{FF2B5EF4-FFF2-40B4-BE49-F238E27FC236}">
                      <a16:creationId xmlns:a16="http://schemas.microsoft.com/office/drawing/2014/main" id="{DEA65FE2-742B-AF89-0D1F-C80414FBE69B}"/>
                    </a:ext>
                  </a:extLst>
                </p:cNvPr>
                <p:cNvSpPr/>
                <p:nvPr/>
              </p:nvSpPr>
              <p:spPr>
                <a:xfrm>
                  <a:off x="4524146" y="2204026"/>
                  <a:ext cx="250361" cy="26278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fr-FR" sz="1200" dirty="0">
                      <a:solidFill>
                        <a:schemeClr val="tx1"/>
                      </a:solidFill>
                    </a:rPr>
                    <a:t>e</a:t>
                  </a:r>
                </a:p>
              </p:txBody>
            </p:sp>
            <p:sp>
              <p:nvSpPr>
                <p:cNvPr id="20" name="Rectangle 19">
                  <a:extLst>
                    <a:ext uri="{FF2B5EF4-FFF2-40B4-BE49-F238E27FC236}">
                      <a16:creationId xmlns:a16="http://schemas.microsoft.com/office/drawing/2014/main" id="{79057248-65F7-FA27-8B1A-F6D43D10F804}"/>
                    </a:ext>
                  </a:extLst>
                </p:cNvPr>
                <p:cNvSpPr/>
                <p:nvPr/>
              </p:nvSpPr>
              <p:spPr>
                <a:xfrm>
                  <a:off x="5085586" y="188576"/>
                  <a:ext cx="250361" cy="26278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fr-FR" sz="1200" dirty="0">
                      <a:solidFill>
                        <a:schemeClr val="tx1"/>
                      </a:solidFill>
                    </a:rPr>
                    <a:t>c</a:t>
                  </a:r>
                </a:p>
              </p:txBody>
            </p:sp>
          </p:grpSp>
        </p:grpSp>
      </p:grpSp>
      <p:sp>
        <p:nvSpPr>
          <p:cNvPr id="21" name="ZoneTexte 20">
            <a:extLst>
              <a:ext uri="{FF2B5EF4-FFF2-40B4-BE49-F238E27FC236}">
                <a16:creationId xmlns:a16="http://schemas.microsoft.com/office/drawing/2014/main" id="{BA63A9E1-3703-0EF0-B3BF-1EA0AC734E68}"/>
              </a:ext>
            </a:extLst>
          </p:cNvPr>
          <p:cNvSpPr txBox="1"/>
          <p:nvPr/>
        </p:nvSpPr>
        <p:spPr>
          <a:xfrm>
            <a:off x="7550331" y="5826034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25918800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97</TotalTime>
  <Words>856</Words>
  <Application>Microsoft Macintosh PowerPoint</Application>
  <PresentationFormat>Grand écran</PresentationFormat>
  <Paragraphs>53</Paragraphs>
  <Slides>8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deline milliex</dc:creator>
  <cp:lastModifiedBy>renaud Siboni</cp:lastModifiedBy>
  <cp:revision>8</cp:revision>
  <dcterms:created xsi:type="dcterms:W3CDTF">2021-12-17T08:37:26Z</dcterms:created>
  <dcterms:modified xsi:type="dcterms:W3CDTF">2025-03-17T09:42:29Z</dcterms:modified>
</cp:coreProperties>
</file>